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12"/>
  </p:notesMasterIdLst>
  <p:sldIdLst>
    <p:sldId id="273" r:id="rId5"/>
    <p:sldId id="275" r:id="rId6"/>
    <p:sldId id="276" r:id="rId7"/>
    <p:sldId id="277" r:id="rId8"/>
    <p:sldId id="269" r:id="rId9"/>
    <p:sldId id="274" r:id="rId10"/>
    <p:sldId id="271" r:id="rId11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746"/>
    <p:restoredTop sz="96301"/>
  </p:normalViewPr>
  <p:slideViewPr>
    <p:cSldViewPr snapToGrid="0">
      <p:cViewPr varScale="1">
        <p:scale>
          <a:sx n="75" d="100"/>
          <a:sy n="75" d="100"/>
        </p:scale>
        <p:origin x="232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D66107-CCC5-404D-BDEA-CBCE878C2008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41D8D5F-6D03-49A7-BEC7-F21E53E190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808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AC3C0-A3BF-F742-AC0C-75E8CB70CA8B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60CE79-CC70-1A4B-9EC0-4B4FD9085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1131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AC3C0-A3BF-F742-AC0C-75E8CB70CA8B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60CE79-CC70-1A4B-9EC0-4B4FD9085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091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AC3C0-A3BF-F742-AC0C-75E8CB70CA8B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60CE79-CC70-1A4B-9EC0-4B4FD9085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2568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AC3C0-A3BF-F742-AC0C-75E8CB70CA8B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60CE79-CC70-1A4B-9EC0-4B4FD9085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5320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AC3C0-A3BF-F742-AC0C-75E8CB70CA8B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60CE79-CC70-1A4B-9EC0-4B4FD9085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0027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AC3C0-A3BF-F742-AC0C-75E8CB70CA8B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60CE79-CC70-1A4B-9EC0-4B4FD9085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46412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AC3C0-A3BF-F742-AC0C-75E8CB70CA8B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60CE79-CC70-1A4B-9EC0-4B4FD9085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2789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AC3C0-A3BF-F742-AC0C-75E8CB70CA8B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60CE79-CC70-1A4B-9EC0-4B4FD9085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8400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AC3C0-A3BF-F742-AC0C-75E8CB70CA8B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60CE79-CC70-1A4B-9EC0-4B4FD9085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8330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AC3C0-A3BF-F742-AC0C-75E8CB70CA8B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60CE79-CC70-1A4B-9EC0-4B4FD9085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5375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AC3C0-A3BF-F742-AC0C-75E8CB70CA8B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60CE79-CC70-1A4B-9EC0-4B4FD9085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624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0AC3C0-A3BF-F742-AC0C-75E8CB70CA8B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60CE79-CC70-1A4B-9EC0-4B4FD9085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769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emf"/><Relationship Id="rId7" Type="http://schemas.openxmlformats.org/officeDocument/2006/relationships/image" Target="../media/image10.png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emf"/><Relationship Id="rId10" Type="http://schemas.openxmlformats.org/officeDocument/2006/relationships/image" Target="../media/image13.emf"/><Relationship Id="rId4" Type="http://schemas.openxmlformats.org/officeDocument/2006/relationships/image" Target="../media/image7.emf"/><Relationship Id="rId9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3" Type="http://schemas.openxmlformats.org/officeDocument/2006/relationships/image" Target="../media/image15.emf"/><Relationship Id="rId7" Type="http://schemas.openxmlformats.org/officeDocument/2006/relationships/image" Target="../media/image19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emf"/><Relationship Id="rId5" Type="http://schemas.openxmlformats.org/officeDocument/2006/relationships/image" Target="../media/image17.emf"/><Relationship Id="rId4" Type="http://schemas.openxmlformats.org/officeDocument/2006/relationships/image" Target="../media/image16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7" Type="http://schemas.openxmlformats.org/officeDocument/2006/relationships/image" Target="../media/image26.em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emf"/><Relationship Id="rId5" Type="http://schemas.openxmlformats.org/officeDocument/2006/relationships/image" Target="../media/image24.emf"/><Relationship Id="rId4" Type="http://schemas.openxmlformats.org/officeDocument/2006/relationships/image" Target="../media/image2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39679" y="522472"/>
            <a:ext cx="27138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s</a:t>
            </a:r>
          </a:p>
        </p:txBody>
      </p:sp>
      <p:sp>
        <p:nvSpPr>
          <p:cNvPr id="3" name="Rectangle 2"/>
          <p:cNvSpPr/>
          <p:nvPr/>
        </p:nvSpPr>
        <p:spPr>
          <a:xfrm>
            <a:off x="266039" y="1133133"/>
            <a:ext cx="6261100" cy="171989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HK" sz="1600" b="1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PFOS-elicited Metabolic Perturbation in Liver and Fatty Acid Metabolites in Testis of Adult Mice</a:t>
            </a:r>
            <a:endParaRPr lang="en-US" sz="1600" kern="100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HK" sz="1600" b="1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 </a:t>
            </a:r>
            <a:endParaRPr lang="en-US" sz="1600" kern="100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  <a:spcAft>
                <a:spcPts val="0"/>
              </a:spcAft>
            </a:pPr>
            <a:r>
              <a:rPr lang="en-HK" sz="1100" b="1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LEE Wang Ka</a:t>
            </a:r>
            <a:r>
              <a:rPr lang="en-HK" sz="1100" b="1" kern="100" baseline="300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1</a:t>
            </a:r>
            <a:r>
              <a:rPr lang="en-HK" sz="1100" b="1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, LAM Thomas </a:t>
            </a:r>
            <a:r>
              <a:rPr lang="en-HK" sz="1100" b="1" kern="10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Ka</a:t>
            </a:r>
            <a:r>
              <a:rPr lang="en-HK" sz="1100" b="1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Yam</a:t>
            </a:r>
            <a:r>
              <a:rPr lang="en-HK" sz="1100" b="1" kern="100" baseline="300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2</a:t>
            </a:r>
            <a:r>
              <a:rPr lang="en-HK" sz="1100" b="1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, </a:t>
            </a:r>
            <a:r>
              <a:rPr lang="en-HK" sz="1100" b="1" kern="10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Hiu</a:t>
            </a:r>
            <a:r>
              <a:rPr lang="en-HK" sz="1100" b="1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</a:t>
            </a:r>
            <a:r>
              <a:rPr lang="en-HK" sz="1100" b="1" kern="10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Ching</a:t>
            </a:r>
            <a:r>
              <a:rPr lang="en-HK" sz="1100" b="1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TANG</a:t>
            </a:r>
            <a:r>
              <a:rPr lang="en-HK" sz="1100" b="1" kern="100" baseline="300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1</a:t>
            </a:r>
            <a:r>
              <a:rPr lang="en-HK" sz="1100" b="1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, HO </a:t>
            </a:r>
            <a:r>
              <a:rPr lang="en-HK" sz="1100" b="1" kern="10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Tsz</a:t>
            </a:r>
            <a:r>
              <a:rPr lang="en-HK" sz="1100" b="1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Chun</a:t>
            </a:r>
            <a:r>
              <a:rPr lang="en-HK" sz="1100" b="1" kern="100" baseline="300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1, 2</a:t>
            </a:r>
            <a:r>
              <a:rPr lang="en-HK" sz="1100" b="1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,</a:t>
            </a:r>
            <a:r>
              <a:rPr lang="en-HK" sz="1100" b="1" kern="100" baseline="300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</a:t>
            </a:r>
            <a:r>
              <a:rPr lang="en-HK" sz="1100" b="1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WAN </a:t>
            </a:r>
            <a:r>
              <a:rPr lang="en-HK" sz="1100" b="1" kern="10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Hin</a:t>
            </a:r>
            <a:r>
              <a:rPr lang="en-HK" sz="1100" b="1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Ting</a:t>
            </a:r>
            <a:r>
              <a:rPr lang="en-HK" sz="1100" b="1" kern="100" baseline="300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1*</a:t>
            </a:r>
            <a:r>
              <a:rPr lang="en-HK" sz="1100" b="1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, WONG Chris Kong Chu</a:t>
            </a:r>
            <a:r>
              <a:rPr lang="en-HK" sz="1100" b="1" kern="100" baseline="300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1*</a:t>
            </a:r>
            <a:endParaRPr lang="en-US" sz="1100" kern="100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HK" sz="1000" kern="100" baseline="30000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1</a:t>
            </a:r>
            <a:r>
              <a:rPr lang="en-HK" sz="1000" kern="100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Croucher Institute for Environmental Sciences, Department of Biology, Hong Kong Baptist University;</a:t>
            </a:r>
            <a:endParaRPr lang="en-US" sz="1000" kern="100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HK" sz="1000" kern="100" baseline="30000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2</a:t>
            </a:r>
            <a:r>
              <a:rPr lang="en-HK" sz="1000" kern="100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State Key</a:t>
            </a:r>
            <a:r>
              <a:rPr lang="en-HK" sz="1000" kern="100" baseline="30000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</a:t>
            </a:r>
            <a:r>
              <a:rPr lang="en-HK" sz="1000" kern="100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Laboratory in Environmental and Biological Analysis, Hong Kong Baptist University, Hong Kong SAR; </a:t>
            </a:r>
            <a:endParaRPr lang="en-US" sz="1000" kern="100" dirty="0">
              <a:effectLst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533400" y="3667818"/>
            <a:ext cx="5372100" cy="476797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. Table S1A.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list of real-time PCR primers.</a:t>
            </a:r>
          </a:p>
          <a:p>
            <a:pPr algn="just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. Table S1B.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list of antibodies.</a:t>
            </a:r>
          </a:p>
          <a:p>
            <a:pPr algn="just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. Table S2.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-imaging data of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achidate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eicosa-5, 8, 11-trienoic acid &amp; eicosa-5, 11, 14-trienoic acid) and the polyunsaturated fatty acids (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homo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α-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nolenic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,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homo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-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nolenic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, 305.24860 m/z). </a:t>
            </a:r>
          </a:p>
          <a:p>
            <a:pPr algn="just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. Table S3.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-imaging data of oxidized ceramides (572.46608 m/z, 626.51867 m/z, 650.48032 m/z).</a:t>
            </a:r>
          </a:p>
          <a:p>
            <a:pPr algn="just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. Table S4.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-imaging data of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acylglycerol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DAG, 575.46943 m/z).</a:t>
            </a:r>
          </a:p>
          <a:p>
            <a:pPr algn="just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. Table S5.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-imaging data of phospholipids (phosphatidylcholine &amp;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atidyl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thanolamine, 750.52802 m/z).</a:t>
            </a: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endParaRPr lang="en-US" sz="10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endParaRPr lang="en-US" sz="10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000" b="1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. Fig. S1. </a:t>
            </a:r>
            <a:r>
              <a:rPr lang="en-US" sz="1000" b="1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relative protein expression level of </a:t>
            </a:r>
            <a:r>
              <a:rPr lang="en-US" sz="1000" kern="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CC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o ACC. </a:t>
            </a:r>
            <a:r>
              <a:rPr lang="en-US" sz="1000" b="1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000" b="1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US" sz="10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ne expression levels of hepatokines including angiopoietin-like 3 (</a:t>
            </a:r>
            <a:r>
              <a:rPr lang="en-US" sz="10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gptl3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angiopoietin-like 6 (</a:t>
            </a:r>
            <a:r>
              <a:rPr lang="en-US" sz="10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gptl6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sz="1000" kern="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lenoprotein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 (</a:t>
            </a:r>
            <a:r>
              <a:rPr lang="en-US" sz="1000" i="1" kern="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lenop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SPARC related modular calcium binding 1 (</a:t>
            </a:r>
            <a:r>
              <a:rPr lang="en-US" sz="10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moc1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in liver. Actin served as the endogenous control. </a:t>
            </a:r>
            <a:r>
              <a:rPr lang="en-US" sz="1000" b="1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sz="10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tein expression levels of phosphorylated insulin receptor substrate (IRS) (</a:t>
            </a:r>
            <a:r>
              <a:rPr lang="en-US" sz="10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r636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total IRS and IR in testis. Graphs show the mean ± S.D.</a:t>
            </a:r>
            <a:endParaRPr lang="en-US" sz="1000" kern="100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000" b="1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. Fig. S2.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ne expression levels of </a:t>
            </a:r>
            <a:r>
              <a:rPr lang="en-US" sz="1000" b="1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llicle-stimulating hormone receptor (</a:t>
            </a:r>
            <a:r>
              <a:rPr lang="en-US" sz="1000" i="1" kern="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shr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luteinizing hormone receptor (</a:t>
            </a:r>
            <a:r>
              <a:rPr lang="en-US" sz="1000" i="1" kern="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hr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sz="1000" b="1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rowth hormone receptor (</a:t>
            </a:r>
            <a:r>
              <a:rPr lang="en-US" sz="1000" i="1" kern="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hr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insulin-like growth factor-1 (</a:t>
            </a:r>
            <a:r>
              <a:rPr lang="en-US" sz="10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gf-1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insulin-like growth factor-1 receptor (</a:t>
            </a:r>
            <a:r>
              <a:rPr lang="en-US" sz="10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gf-1r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US" sz="1000" b="1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hepatocyte growth factor (</a:t>
            </a:r>
            <a:r>
              <a:rPr lang="en-US" sz="1000" i="1" kern="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gf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hepatocyte growth factor receptor (</a:t>
            </a:r>
            <a:r>
              <a:rPr lang="en-US" sz="1000" i="1" kern="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gfr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in testes. Actin served as the endogenous control. Graphs show the mean ± S.D.</a:t>
            </a:r>
            <a:endParaRPr lang="en-US" sz="1000" kern="100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000" b="1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. Fig. S3.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ne expression levels of steroidogenic enzymes including steroidogenic acute regulatory protein (</a:t>
            </a:r>
            <a:r>
              <a:rPr lang="en-US" sz="10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ar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cytochrome P450 family 11 subfamily A member 1 (</a:t>
            </a:r>
            <a:r>
              <a:rPr lang="en-US" sz="10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yp11α1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cytochrome P450 family 17 subfamily A member 1 (</a:t>
            </a:r>
            <a:r>
              <a:rPr lang="en-US" sz="10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yp17α1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3β-</a:t>
            </a:r>
            <a:r>
              <a:rPr lang="en-US" sz="1000" kern="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ydroxysteroid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ehydrogenase (</a:t>
            </a:r>
            <a:r>
              <a:rPr lang="en-US" sz="10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sd3</a:t>
            </a:r>
            <a:r>
              <a:rPr lang="en-US" sz="10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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17β-</a:t>
            </a:r>
            <a:r>
              <a:rPr lang="en-US" sz="1000" kern="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ydroxysteroid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ehydrogenase (</a:t>
            </a:r>
            <a:r>
              <a:rPr lang="en-US" sz="10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sd17</a:t>
            </a:r>
            <a:r>
              <a:rPr lang="en-US" sz="10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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steroid 5α-reductase 2 (</a:t>
            </a:r>
            <a:r>
              <a:rPr lang="en-US" sz="10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rd5α2</a:t>
            </a:r>
            <a:r>
              <a:rPr lang="en-US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in testis. Actin served as the endogenous control. Graphs show the mean ± S.D.</a:t>
            </a:r>
            <a:endParaRPr lang="en-US" sz="1000" kern="100" dirty="0">
              <a:effectLst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85219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9736689"/>
              </p:ext>
            </p:extLst>
          </p:nvPr>
        </p:nvGraphicFramePr>
        <p:xfrm>
          <a:off x="471488" y="672609"/>
          <a:ext cx="5915025" cy="506097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17303">
                  <a:extLst>
                    <a:ext uri="{9D8B030D-6E8A-4147-A177-3AD203B41FA5}">
                      <a16:colId xmlns:a16="http://schemas.microsoft.com/office/drawing/2014/main" val="2635903236"/>
                    </a:ext>
                  </a:extLst>
                </a:gridCol>
                <a:gridCol w="2475454">
                  <a:extLst>
                    <a:ext uri="{9D8B030D-6E8A-4147-A177-3AD203B41FA5}">
                      <a16:colId xmlns:a16="http://schemas.microsoft.com/office/drawing/2014/main" val="173963852"/>
                    </a:ext>
                  </a:extLst>
                </a:gridCol>
                <a:gridCol w="2522268">
                  <a:extLst>
                    <a:ext uri="{9D8B030D-6E8A-4147-A177-3AD203B41FA5}">
                      <a16:colId xmlns:a16="http://schemas.microsoft.com/office/drawing/2014/main" val="3338043414"/>
                    </a:ext>
                  </a:extLst>
                </a:gridCol>
              </a:tblGrid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Primer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Forward Sequence (5’ to3’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 dirty="0">
                          <a:effectLst/>
                        </a:rPr>
                        <a:t>Reverse Sequence (5’ to 3’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1410046173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m-Fshr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TCTGCATGGCCCCAATTTT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GGTAGAACAGAACTAGGAGGAT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4210882772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m-Lhr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GCACTCTCCAGAGTTGTCA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AGGGAGATAGGTGAGAGATAGT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75887689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m-Ghr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ACTGTCCAGTGTACTCATTGAGA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CATGCTTCCAATATGTTCGTCTG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3609463409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m-Igf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GCCCCACTGAAGCCTACAAA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GTACTTCCTTTCCTTCTCCTTTG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3072305428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m-Igf1r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CAGACACTACTACAAAGGCG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GATAACGAAGCCATCCGAGTC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968389575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m-Star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GGAACCCAAATGTCAAGGAGATC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 dirty="0">
                          <a:effectLst/>
                        </a:rPr>
                        <a:t>GCACGCTCACGAAGTCTCG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1680338767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m-Cyp11a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AGCTGGGCAACATGGAGTC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CCTCTGGTAATACTGGTGATAGG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487681986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m-Cyp17a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GATCTAAGAAGCTCAGGC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GGGCACTGCATCACGATAA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818543764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m-Hsd3b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GTGACAGTGTTGGAAGGAGAC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GACATCAATGACAGCAGCAGT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3948674726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m-Hsd17b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CTGGTGAAGTGCATGAGGTTC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TCAAATGAATAGGCTTTCCCGAT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3068961093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m-Srd5a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CCGCACATTACTTCCACAG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GAAGACACCGACGCTAAAC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85780519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m-Hgf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 dirty="0">
                          <a:effectLst/>
                        </a:rPr>
                        <a:t>GTTCATGAGAGAGGCGAGG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 dirty="0">
                          <a:effectLst/>
                        </a:rPr>
                        <a:t>CGCGTTGATCAATCCAGTGT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2256184548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m-Hgfr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GTTCTGCTTGGCAACGAGAGC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 dirty="0">
                          <a:effectLst/>
                        </a:rPr>
                        <a:t>GGAGAATGCACTGTATTGCGTCG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3620582174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m-Slc2a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 dirty="0">
                          <a:effectLst/>
                        </a:rPr>
                        <a:t>TCGGTCACTGTGGGCATAATC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 dirty="0">
                          <a:effectLst/>
                        </a:rPr>
                        <a:t>CCCTGCTCTGTCCATGATG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3057963393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m-Srd5a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GCCGATACTTGAGCCAGTTTG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CTCAGATTCCGCAGGATGTGG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1657041116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m-Smoc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CCAAGCCCAAGAAATGTGC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 dirty="0">
                          <a:effectLst/>
                        </a:rPr>
                        <a:t>AGTCCTGTCTCCTCGGAGTT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1023475824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m-Angptl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GGACTGGGATGGCAATG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CCTCACCCCCCAAATG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1338091811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m-Angptl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ACTTCAGATGGAGGCTGG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TCCGAAGCCATCCTTGTAG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273854132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m-Angptl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CTTCACCAACTGGCAGCACTAC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CTAGGAGTATCAGCAGCTCGTGGT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843771418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m-Fgf2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GAAGGACTCCCCAAACCAG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GAAGAGTCAGGACGCATAG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2753609649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m-Lect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CCCACAACAATCCTCATTTC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GTTAGCCCATGGTCCTGCT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2368898358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m-Rbp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GACAAGGCTCGTTTCTCTG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AAAGGAGGCTACACCCCAG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1459949827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 dirty="0">
                          <a:effectLst/>
                        </a:rPr>
                        <a:t>m-</a:t>
                      </a:r>
                      <a:r>
                        <a:rPr lang="en-HK" sz="1000" dirty="0" err="1">
                          <a:effectLst/>
                        </a:rPr>
                        <a:t>SelenoP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ACTCGTCAAAAGTCGTCCG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 dirty="0">
                          <a:effectLst/>
                        </a:rPr>
                        <a:t>ACCACTGTCACTTTGCCCTC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2298792245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 dirty="0">
                          <a:effectLst/>
                        </a:rPr>
                        <a:t>m-Pgc1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 dirty="0">
                          <a:effectLst/>
                        </a:rPr>
                        <a:t>CTGCATGAGTGTGTGCTGTG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 dirty="0">
                          <a:effectLst/>
                        </a:rPr>
                        <a:t>ATCTGGGCAAAGAGGCTGG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3868327784"/>
                  </a:ext>
                </a:extLst>
              </a:tr>
            </a:tbl>
          </a:graphicData>
        </a:graphic>
      </p:graphicFrame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382588" y="395610"/>
            <a:ext cx="3376565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TW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. Table S1A: </a:t>
            </a:r>
            <a:r>
              <a:rPr kumimoji="0" lang="en-US" altLang="zh-TW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 list of real-time PCR primers.</a:t>
            </a:r>
            <a:endParaRPr kumimoji="0" lang="en-US" altLang="zh-TW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zh-TW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83727542"/>
              </p:ext>
            </p:extLst>
          </p:nvPr>
        </p:nvGraphicFramePr>
        <p:xfrm>
          <a:off x="471488" y="6772130"/>
          <a:ext cx="5915024" cy="2226829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353534">
                  <a:extLst>
                    <a:ext uri="{9D8B030D-6E8A-4147-A177-3AD203B41FA5}">
                      <a16:colId xmlns:a16="http://schemas.microsoft.com/office/drawing/2014/main" val="1279604570"/>
                    </a:ext>
                  </a:extLst>
                </a:gridCol>
                <a:gridCol w="649071">
                  <a:extLst>
                    <a:ext uri="{9D8B030D-6E8A-4147-A177-3AD203B41FA5}">
                      <a16:colId xmlns:a16="http://schemas.microsoft.com/office/drawing/2014/main" val="4014711565"/>
                    </a:ext>
                  </a:extLst>
                </a:gridCol>
                <a:gridCol w="1015992">
                  <a:extLst>
                    <a:ext uri="{9D8B030D-6E8A-4147-A177-3AD203B41FA5}">
                      <a16:colId xmlns:a16="http://schemas.microsoft.com/office/drawing/2014/main" val="3769075467"/>
                    </a:ext>
                  </a:extLst>
                </a:gridCol>
                <a:gridCol w="896427">
                  <a:extLst>
                    <a:ext uri="{9D8B030D-6E8A-4147-A177-3AD203B41FA5}">
                      <a16:colId xmlns:a16="http://schemas.microsoft.com/office/drawing/2014/main" val="788821929"/>
                    </a:ext>
                  </a:extLst>
                </a:gridCol>
              </a:tblGrid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Antibody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Hos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 dirty="0">
                          <a:effectLst/>
                        </a:rPr>
                        <a:t>Brand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Cat. no.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3594703846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Actin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Mous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Sigm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A222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335530618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FASN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Rabbi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Cell Signalin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 dirty="0">
                          <a:effectLst/>
                        </a:rPr>
                        <a:t>318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365579968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p-ATP citrate lyas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Rabbi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Cell Signalin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 dirty="0">
                          <a:effectLst/>
                        </a:rPr>
                        <a:t>4331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1941515791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ATP-citrate lyas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Rabbi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Cell Signalin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433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3867394646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p-Acac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Rabbi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Cell Signalin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1181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2776304855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Acac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Rabbi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Cell Signalin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367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556944820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Insulin receptor b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Rabbi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Cell Signalin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302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2291867481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 dirty="0">
                          <a:effectLst/>
                        </a:rPr>
                        <a:t>IGF-I Receptor β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Rabbi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Cell Signalin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 dirty="0">
                          <a:effectLst/>
                        </a:rPr>
                        <a:t>975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4102692278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 dirty="0">
                          <a:effectLst/>
                        </a:rPr>
                        <a:t>Phospho-IRS-1 (Ser636/639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Rabbi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Cell Signalin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 dirty="0">
                          <a:effectLst/>
                        </a:rPr>
                        <a:t>2388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3273881198"/>
                  </a:ext>
                </a:extLst>
              </a:tr>
              <a:tr h="202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 dirty="0">
                          <a:effectLst/>
                        </a:rPr>
                        <a:t>IRS-1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Rabbi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>
                          <a:effectLst/>
                        </a:rPr>
                        <a:t>Cell Signalin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HK" sz="1000" dirty="0">
                          <a:effectLst/>
                        </a:rPr>
                        <a:t>3407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4155125021"/>
                  </a:ext>
                </a:extLst>
              </a:tr>
            </a:tbl>
          </a:graphicData>
        </a:graphic>
      </p:graphicFrame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382588" y="6495131"/>
            <a:ext cx="3363912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TW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. Table S1B. </a:t>
            </a:r>
            <a:r>
              <a:rPr kumimoji="0" lang="en-US" altLang="zh-TW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 list of antibodies.</a:t>
            </a:r>
            <a:endParaRPr kumimoji="0" lang="en-US" altLang="zh-TW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zh-TW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2471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11748" y="696562"/>
            <a:ext cx="59300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Table S2: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-imaging data of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ly-unsaturated fatty acids.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311748" y="2179499"/>
            <a:ext cx="5930050" cy="4490361"/>
            <a:chOff x="311748" y="2038170"/>
            <a:chExt cx="5930050" cy="4490361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72709" y="2320828"/>
              <a:ext cx="5869089" cy="4207703"/>
            </a:xfrm>
            <a:prstGeom prst="rect">
              <a:avLst/>
            </a:prstGeom>
          </p:spPr>
        </p:pic>
        <p:sp>
          <p:nvSpPr>
            <p:cNvPr id="7" name="Rectangle 6"/>
            <p:cNvSpPr/>
            <p:nvPr/>
          </p:nvSpPr>
          <p:spPr>
            <a:xfrm>
              <a:off x="311748" y="2038170"/>
              <a:ext cx="5930049" cy="26930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lnSpc>
                  <a:spcPct val="115000"/>
                </a:lnSpc>
                <a:spcAft>
                  <a:spcPts val="0"/>
                </a:spcAft>
              </a:pPr>
              <a:r>
                <a:rPr lang="en-US" sz="1000" b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Suppl. Table S3. </a:t>
              </a:r>
              <a:r>
                <a:rPr lang="en-US" sz="10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MS-imaging data of oxidized </a:t>
              </a:r>
              <a:r>
                <a:rPr lang="en-US" sz="1000" dirty="0" smtClean="0">
                  <a:latin typeface="Times New Roman" panose="02020603050405020304" pitchFamily="18" charset="0"/>
                  <a:ea typeface="Times New Roman" panose="02020603050405020304" pitchFamily="18" charset="0"/>
                </a:rPr>
                <a:t>ceramides.</a:t>
              </a:r>
              <a:endParaRPr lang="en-US" sz="10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342227" y="7313313"/>
            <a:ext cx="5930050" cy="1239873"/>
            <a:chOff x="311747" y="7983128"/>
            <a:chExt cx="5930050" cy="1239873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2708" y="8252432"/>
              <a:ext cx="5869089" cy="970569"/>
            </a:xfrm>
            <a:prstGeom prst="rect">
              <a:avLst/>
            </a:prstGeom>
          </p:spPr>
        </p:pic>
        <p:sp>
          <p:nvSpPr>
            <p:cNvPr id="10" name="Rectangle 9"/>
            <p:cNvSpPr/>
            <p:nvPr/>
          </p:nvSpPr>
          <p:spPr>
            <a:xfrm>
              <a:off x="311747" y="7983128"/>
              <a:ext cx="5930049" cy="26930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lnSpc>
                  <a:spcPct val="115000"/>
                </a:lnSpc>
                <a:spcAft>
                  <a:spcPts val="0"/>
                </a:spcAft>
              </a:pPr>
              <a:r>
                <a:rPr lang="en-US" sz="1000" b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Suppl. Table S4. </a:t>
              </a:r>
              <a:r>
                <a:rPr lang="en-US" sz="10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MS-imaging data of </a:t>
              </a:r>
              <a:r>
                <a:rPr lang="en-US" sz="1000" dirty="0" err="1" smtClean="0">
                  <a:latin typeface="Times New Roman" panose="02020603050405020304" pitchFamily="18" charset="0"/>
                  <a:ea typeface="Times New Roman" panose="02020603050405020304" pitchFamily="18" charset="0"/>
                </a:rPr>
                <a:t>diacylglycerol</a:t>
              </a:r>
              <a:r>
                <a:rPr lang="en-US" sz="1000" dirty="0" smtClean="0">
                  <a:latin typeface="Times New Roman" panose="02020603050405020304" pitchFamily="18" charset="0"/>
                  <a:ea typeface="Times New Roman" panose="02020603050405020304" pitchFamily="18" charset="0"/>
                </a:rPr>
                <a:t>.</a:t>
              </a:r>
              <a:endParaRPr lang="en-US" sz="10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7466" y="956137"/>
            <a:ext cx="5884331" cy="6124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26557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501798" y="586458"/>
            <a:ext cx="5885856" cy="6229071"/>
            <a:chOff x="501798" y="586458"/>
            <a:chExt cx="5885856" cy="6229071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01799" y="1032734"/>
              <a:ext cx="5885855" cy="5782795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501798" y="586458"/>
              <a:ext cx="5885855" cy="26930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lnSpc>
                  <a:spcPct val="115000"/>
                </a:lnSpc>
                <a:spcAft>
                  <a:spcPts val="0"/>
                </a:spcAft>
              </a:pPr>
              <a:r>
                <a:rPr lang="en-US" sz="1000" b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Suppl. Table S5. </a:t>
              </a:r>
              <a:r>
                <a:rPr lang="en-US" sz="10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MS-imaging data of phospholipids (phosphatidylcholine &amp; </a:t>
              </a:r>
              <a:r>
                <a:rPr lang="en-US" sz="1000" dirty="0" smtClean="0">
                  <a:latin typeface="Times New Roman" panose="02020603050405020304" pitchFamily="18" charset="0"/>
                  <a:ea typeface="Times New Roman" panose="02020603050405020304" pitchFamily="18" charset="0"/>
                </a:rPr>
                <a:t>phosphatidylethanolamine).</a:t>
              </a:r>
              <a:endParaRPr lang="en-US" sz="10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995348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84607" y="192505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S1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40663" y="3598762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(B)</a:t>
            </a:r>
            <a:endParaRPr 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40663" y="6846936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(C)</a:t>
            </a:r>
            <a:endParaRPr lang="en-US" b="1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B4C7E5DB-2DF6-35BB-DC53-4773A2B68D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5381" y="3968094"/>
            <a:ext cx="1917700" cy="25019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0121990-69B6-B1E6-F5C8-0FB02C8A241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13227" y="3968094"/>
            <a:ext cx="1524000" cy="25019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96C0258D-B266-6329-C4EE-19C3455A1F8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37373" y="3968094"/>
            <a:ext cx="1524000" cy="25019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F01A1787-F74F-3461-B83A-4B888CC0820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61519" y="3968094"/>
            <a:ext cx="1524000" cy="2501900"/>
          </a:xfrm>
          <a:prstGeom prst="rect">
            <a:avLst/>
          </a:prstGeom>
        </p:spPr>
      </p:pic>
      <p:grpSp>
        <p:nvGrpSpPr>
          <p:cNvPr id="2" name="Group 1"/>
          <p:cNvGrpSpPr/>
          <p:nvPr/>
        </p:nvGrpSpPr>
        <p:grpSpPr>
          <a:xfrm>
            <a:off x="140663" y="7031602"/>
            <a:ext cx="2622894" cy="2321665"/>
            <a:chOff x="520243" y="6989256"/>
            <a:chExt cx="2622894" cy="2321665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C9A6B4E2-F628-C71E-8058-9EBA6C4E9C8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69666"/>
            <a:stretch/>
          </p:blipFill>
          <p:spPr>
            <a:xfrm>
              <a:off x="2051053" y="8761443"/>
              <a:ext cx="1092009" cy="251163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6ED3EFDE-26D5-7A74-7E76-7BB5366184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r="69668"/>
            <a:stretch/>
          </p:blipFill>
          <p:spPr>
            <a:xfrm>
              <a:off x="2051127" y="8190647"/>
              <a:ext cx="1091935" cy="251163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E805D25C-001D-74F6-FB26-C2CD135115E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-2" r="69669"/>
            <a:stretch/>
          </p:blipFill>
          <p:spPr>
            <a:xfrm>
              <a:off x="2051127" y="8476045"/>
              <a:ext cx="1092010" cy="251163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FC989CA1-A221-AEBF-CA38-67B537524E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284" r="69389"/>
            <a:stretch/>
          </p:blipFill>
          <p:spPr>
            <a:xfrm>
              <a:off x="2051053" y="9046841"/>
              <a:ext cx="1091753" cy="251163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2251A983-5E01-DBFF-89B1-116506EA3B02}"/>
                </a:ext>
              </a:extLst>
            </p:cNvPr>
            <p:cNvSpPr txBox="1"/>
            <p:nvPr/>
          </p:nvSpPr>
          <p:spPr>
            <a:xfrm>
              <a:off x="520243" y="8463126"/>
              <a:ext cx="15308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Helvetica" pitchFamily="2" charset="0"/>
                  <a:cs typeface="Times New Roman" panose="02020603050405020304" pitchFamily="18" charset="0"/>
                </a:rPr>
                <a:t>IRS</a:t>
              </a:r>
              <a:endParaRPr lang="en-US" sz="900" dirty="0">
                <a:latin typeface="Helvetica" pitchFamily="2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B8340A6-8CCB-39D1-2291-D10BE2BED0CB}"/>
                </a:ext>
              </a:extLst>
            </p:cNvPr>
            <p:cNvSpPr txBox="1"/>
            <p:nvPr/>
          </p:nvSpPr>
          <p:spPr>
            <a:xfrm>
              <a:off x="520244" y="8177730"/>
              <a:ext cx="15308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Helvetica" pitchFamily="2" charset="0"/>
                  <a:cs typeface="Times New Roman" panose="02020603050405020304" pitchFamily="18" charset="0"/>
                </a:rPr>
                <a:t>p-IRS </a:t>
              </a:r>
              <a:r>
                <a:rPr lang="en-US" sz="900" dirty="0">
                  <a:latin typeface="Helvetica" pitchFamily="2" charset="0"/>
                  <a:cs typeface="Times New Roman" panose="02020603050405020304" pitchFamily="18" charset="0"/>
                </a:rPr>
                <a:t>(Ser636)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DFEF5B9A-21AE-F85F-6458-2C3A8F801797}"/>
                </a:ext>
              </a:extLst>
            </p:cNvPr>
            <p:cNvSpPr txBox="1"/>
            <p:nvPr/>
          </p:nvSpPr>
          <p:spPr>
            <a:xfrm>
              <a:off x="1428331" y="8749745"/>
              <a:ext cx="6227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Helvetica" pitchFamily="2" charset="0"/>
                  <a:cs typeface="Times New Roman" panose="02020603050405020304" pitchFamily="18" charset="0"/>
                </a:rPr>
                <a:t>IR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7027762-DC80-F149-FBA3-6670AAAC8A45}"/>
                </a:ext>
              </a:extLst>
            </p:cNvPr>
            <p:cNvSpPr txBox="1"/>
            <p:nvPr/>
          </p:nvSpPr>
          <p:spPr>
            <a:xfrm>
              <a:off x="1250844" y="9033922"/>
              <a:ext cx="7943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Helvetica" pitchFamily="2" charset="0"/>
                  <a:cs typeface="Times New Roman" panose="02020603050405020304" pitchFamily="18" charset="0"/>
                </a:rPr>
                <a:t>Actin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25E7FE80-EA23-3B37-9534-D5FE81E9D6D4}"/>
                </a:ext>
              </a:extLst>
            </p:cNvPr>
            <p:cNvSpPr txBox="1"/>
            <p:nvPr/>
          </p:nvSpPr>
          <p:spPr>
            <a:xfrm rot="16200000">
              <a:off x="2313379" y="7460035"/>
              <a:ext cx="12185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Helvetica" pitchFamily="2" charset="0"/>
                  <a:cs typeface="Times New Roman" panose="02020603050405020304" pitchFamily="18" charset="0"/>
                </a:rPr>
                <a:t>H-PFOS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48DD7BB-663C-D8BF-7222-93EE137DBA95}"/>
                </a:ext>
              </a:extLst>
            </p:cNvPr>
            <p:cNvSpPr txBox="1"/>
            <p:nvPr/>
          </p:nvSpPr>
          <p:spPr>
            <a:xfrm rot="16200000">
              <a:off x="1905805" y="7662914"/>
              <a:ext cx="812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Helvetica" pitchFamily="2" charset="0"/>
                  <a:cs typeface="Times New Roman" panose="02020603050405020304" pitchFamily="18" charset="0"/>
                </a:rPr>
                <a:t>Ctrl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E1FB0056-0BE7-B0DE-3EAD-5ADBA3D45F4D}"/>
                </a:ext>
              </a:extLst>
            </p:cNvPr>
            <p:cNvSpPr txBox="1"/>
            <p:nvPr/>
          </p:nvSpPr>
          <p:spPr>
            <a:xfrm rot="16200000">
              <a:off x="2087871" y="7539754"/>
              <a:ext cx="10591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Helvetica" pitchFamily="2" charset="0"/>
                  <a:cs typeface="Times New Roman" panose="02020603050405020304" pitchFamily="18" charset="0"/>
                </a:rPr>
                <a:t>L-PFOS</a:t>
              </a: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1868186" y="7142616"/>
            <a:ext cx="7393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u="sng" dirty="0"/>
              <a:t>Testis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F5317C50-DD22-6C75-F560-01FA1DF39BA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14278" y="1135502"/>
            <a:ext cx="1828800" cy="2324100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140663" y="770112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A)</a:t>
            </a:r>
          </a:p>
        </p:txBody>
      </p:sp>
    </p:spTree>
    <p:extLst>
      <p:ext uri="{BB962C8B-B14F-4D97-AF65-F5344CB8AC3E}">
        <p14:creationId xmlns:p14="http://schemas.microsoft.com/office/powerpoint/2010/main" val="21448598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184607" y="192505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S2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96FC5627-3677-B495-62E0-90585A1329E1}"/>
              </a:ext>
            </a:extLst>
          </p:cNvPr>
          <p:cNvGrpSpPr/>
          <p:nvPr/>
        </p:nvGrpSpPr>
        <p:grpSpPr>
          <a:xfrm>
            <a:off x="129956" y="566354"/>
            <a:ext cx="3547151" cy="2885025"/>
            <a:chOff x="129956" y="566354"/>
            <a:chExt cx="3547151" cy="2885025"/>
          </a:xfrm>
        </p:grpSpPr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51F3F4B4-4F5D-F4E3-B04F-15A1BFB17C65}"/>
                </a:ext>
              </a:extLst>
            </p:cNvPr>
            <p:cNvSpPr/>
            <p:nvPr/>
          </p:nvSpPr>
          <p:spPr>
            <a:xfrm>
              <a:off x="184607" y="566354"/>
              <a:ext cx="1426857" cy="3556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b="1" dirty="0">
                  <a:solidFill>
                    <a:schemeClr val="tx1"/>
                  </a:solidFill>
                </a:rPr>
                <a:t>(A)</a:t>
              </a:r>
            </a:p>
          </p:txBody>
        </p:sp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DAC1F291-B35A-4BC4-7455-13E82321CD8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9956" y="949479"/>
              <a:ext cx="1917700" cy="2501900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16DA8592-5C15-5D50-13D0-810E28A1BCD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53107" y="949479"/>
              <a:ext cx="1524000" cy="2501900"/>
            </a:xfrm>
            <a:prstGeom prst="rect">
              <a:avLst/>
            </a:prstGeom>
          </p:spPr>
        </p:pic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15110F98-377A-DCFC-E28A-D11FBAC79E2B}"/>
              </a:ext>
            </a:extLst>
          </p:cNvPr>
          <p:cNvGrpSpPr/>
          <p:nvPr/>
        </p:nvGrpSpPr>
        <p:grpSpPr>
          <a:xfrm>
            <a:off x="129956" y="3583007"/>
            <a:ext cx="5175471" cy="2933918"/>
            <a:chOff x="129956" y="3728198"/>
            <a:chExt cx="5175471" cy="2933918"/>
          </a:xfrm>
        </p:grpSpPr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8F848FA9-D557-9772-3936-82029410A148}"/>
                </a:ext>
              </a:extLst>
            </p:cNvPr>
            <p:cNvSpPr/>
            <p:nvPr/>
          </p:nvSpPr>
          <p:spPr>
            <a:xfrm>
              <a:off x="184607" y="3728198"/>
              <a:ext cx="1834630" cy="3556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b="1" dirty="0">
                  <a:solidFill>
                    <a:schemeClr val="tx1"/>
                  </a:solidFill>
                </a:rPr>
                <a:t>(B)</a:t>
              </a:r>
            </a:p>
          </p:txBody>
        </p:sp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918DF7FC-3C98-C0D5-A3BE-99A647F184A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29956" y="4160216"/>
              <a:ext cx="1917700" cy="2501900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FFDD7D12-5F84-E9F7-C72F-463D1190854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153107" y="4160216"/>
              <a:ext cx="1524000" cy="2501900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CDF76D31-9B1E-49F4-BB33-750128ABC94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781427" y="4160216"/>
              <a:ext cx="1524000" cy="2501900"/>
            </a:xfrm>
            <a:prstGeom prst="rect">
              <a:avLst/>
            </a:prstGeom>
          </p:spPr>
        </p:pic>
      </p:grpSp>
      <p:sp>
        <p:nvSpPr>
          <p:cNvPr id="14" name="Rectangle 13">
            <a:extLst>
              <a:ext uri="{FF2B5EF4-FFF2-40B4-BE49-F238E27FC236}">
                <a16:creationId xmlns:a16="http://schemas.microsoft.com/office/drawing/2014/main" id="{8F848FA9-D557-9772-3936-82029410A148}"/>
              </a:ext>
            </a:extLst>
          </p:cNvPr>
          <p:cNvSpPr/>
          <p:nvPr/>
        </p:nvSpPr>
        <p:spPr>
          <a:xfrm>
            <a:off x="184607" y="6791042"/>
            <a:ext cx="1834630" cy="355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b="1" dirty="0">
                <a:solidFill>
                  <a:schemeClr val="tx1"/>
                </a:solidFill>
              </a:rPr>
              <a:t>(C)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F65CEB1C-C2F7-C44C-D05D-F757178B25D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9956" y="7211595"/>
            <a:ext cx="1917700" cy="25019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72DA3A1B-263C-D77F-AC6B-AD5DAE6526D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80107" y="7211595"/>
            <a:ext cx="1397000" cy="2501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6678051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>
            <a:extLst>
              <a:ext uri="{FF2B5EF4-FFF2-40B4-BE49-F238E27FC236}">
                <a16:creationId xmlns:a16="http://schemas.microsoft.com/office/drawing/2014/main" id="{E37C872A-90E8-F0C0-CF81-4B6A698AD5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82558" y="949479"/>
            <a:ext cx="1524000" cy="250190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C75D700F-97B3-9057-7B6F-DC04BE8EDA2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53107" y="949479"/>
            <a:ext cx="1524000" cy="25019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25724190-1106-0CA5-2BBF-85DEB2E2628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9956" y="949479"/>
            <a:ext cx="1917700" cy="2501900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184607" y="192505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S3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F3496D44-56EE-52B1-74C9-D29FB91EF7A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9956" y="3702050"/>
            <a:ext cx="1917700" cy="250190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68B79445-CEAC-6626-CFD4-E4057392E25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53107" y="3702050"/>
            <a:ext cx="1524000" cy="25019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4EBE11B8-AAA8-71BB-34BD-AEBEDE40266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46058" y="3702050"/>
            <a:ext cx="1397000" cy="2501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68067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AFA50CBBF4CD142BAF55481075BDAD2" ma:contentTypeVersion="19" ma:contentTypeDescription="Create a new document." ma:contentTypeScope="" ma:versionID="1de92b734813376301e3a9a00c8173c2">
  <xsd:schema xmlns:xsd="http://www.w3.org/2001/XMLSchema" xmlns:xs="http://www.w3.org/2001/XMLSchema" xmlns:p="http://schemas.microsoft.com/office/2006/metadata/properties" xmlns:ns3="941eeea9-a65b-4b11-8fbe-8d30452b0442" xmlns:ns4="4a9b5b35-3622-4aed-82d4-6e1db90056ca" targetNamespace="http://schemas.microsoft.com/office/2006/metadata/properties" ma:root="true" ma:fieldsID="837bca4e4569dc09dc68b69747c06bb9" ns3:_="" ns4:_="">
    <xsd:import namespace="941eeea9-a65b-4b11-8fbe-8d30452b0442"/>
    <xsd:import namespace="4a9b5b35-3622-4aed-82d4-6e1db90056ca"/>
    <xsd:element name="properties">
      <xsd:complexType>
        <xsd:sequence>
          <xsd:element name="documentManagement">
            <xsd:complexType>
              <xsd:all>
                <xsd:element ref="ns3:MigrationWizId" minOccurs="0"/>
                <xsd:element ref="ns3:MigrationWizIdPermissions" minOccurs="0"/>
                <xsd:element ref="ns3:MigrationWizIdVersion" minOccurs="0"/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LengthInSeconds" minOccurs="0"/>
                <xsd:element ref="ns4:SharedWithUsers" minOccurs="0"/>
                <xsd:element ref="ns4:SharedWithDetails" minOccurs="0"/>
                <xsd:element ref="ns4:SharingHintHash" minOccurs="0"/>
                <xsd:element ref="ns3:_activity" minOccurs="0"/>
                <xsd:element ref="ns3:MediaServiceOCR" minOccurs="0"/>
                <xsd:element ref="ns3:MediaServiceObjectDetectorVersions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41eeea9-a65b-4b11-8fbe-8d30452b0442" elementFormDefault="qualified">
    <xsd:import namespace="http://schemas.microsoft.com/office/2006/documentManagement/types"/>
    <xsd:import namespace="http://schemas.microsoft.com/office/infopath/2007/PartnerControls"/>
    <xsd:element name="MigrationWizId" ma:index="8" nillable="true" ma:displayName="MigrationWizId" ma:internalName="MigrationWizId">
      <xsd:simpleType>
        <xsd:restriction base="dms:Text"/>
      </xsd:simpleType>
    </xsd:element>
    <xsd:element name="MigrationWizIdPermissions" ma:index="9" nillable="true" ma:displayName="MigrationWizIdPermissions" ma:internalName="MigrationWizIdPermissions">
      <xsd:simpleType>
        <xsd:restriction base="dms:Text"/>
      </xsd:simpleType>
    </xsd:element>
    <xsd:element name="MigrationWizIdVersion" ma:index="10" nillable="true" ma:displayName="MigrationWizIdVersion" ma:internalName="MigrationWizIdVersion">
      <xsd:simpleType>
        <xsd:restriction base="dms:Text"/>
      </xsd:simpleType>
    </xsd:element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3" nillable="true" ma:displayName="_activity" ma:hidden="true" ma:internalName="_activity">
      <xsd:simpleType>
        <xsd:restriction base="dms:Note"/>
      </xsd:simpleType>
    </xsd:element>
    <xsd:element name="MediaServiceOCR" ma:index="2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ObjectDetectorVersions" ma:index="2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Location" ma:index="26" nillable="true" ma:displayName="Location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a9b5b35-3622-4aed-82d4-6e1db90056ca" elementFormDefault="qualified">
    <xsd:import namespace="http://schemas.microsoft.com/office/2006/documentManagement/types"/>
    <xsd:import namespace="http://schemas.microsoft.com/office/infopath/2007/PartnerControls"/>
    <xsd:element name="SharedWithUsers" ma:index="2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941eeea9-a65b-4b11-8fbe-8d30452b0442" xsi:nil="true"/>
    <MigrationWizId xmlns="941eeea9-a65b-4b11-8fbe-8d30452b0442" xsi:nil="true"/>
    <MigrationWizIdVersion xmlns="941eeea9-a65b-4b11-8fbe-8d30452b0442" xsi:nil="true"/>
    <MigrationWizIdPermissions xmlns="941eeea9-a65b-4b11-8fbe-8d30452b0442" xsi:nil="true"/>
  </documentManagement>
</p:properties>
</file>

<file path=customXml/itemProps1.xml><?xml version="1.0" encoding="utf-8"?>
<ds:datastoreItem xmlns:ds="http://schemas.openxmlformats.org/officeDocument/2006/customXml" ds:itemID="{889910F0-6144-4B65-8FDC-4DBE542E7A17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8044A31-A6D1-4B89-8407-18B6A6F9D3A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41eeea9-a65b-4b11-8fbe-8d30452b0442"/>
    <ds:schemaRef ds:uri="4a9b5b35-3622-4aed-82d4-6e1db90056c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BFD26EFF-38A8-4FA7-90FC-5C56964395D6}">
  <ds:schemaRefs>
    <ds:schemaRef ds:uri="http://purl.org/dc/terms/"/>
    <ds:schemaRef ds:uri="http://www.w3.org/XML/1998/namespace"/>
    <ds:schemaRef ds:uri="http://purl.org/dc/elements/1.1/"/>
    <ds:schemaRef ds:uri="4a9b5b35-3622-4aed-82d4-6e1db90056ca"/>
    <ds:schemaRef ds:uri="http://schemas.microsoft.com/office/2006/documentManagement/types"/>
    <ds:schemaRef ds:uri="http://schemas.microsoft.com/office/2006/metadata/properties"/>
    <ds:schemaRef ds:uri="http://purl.org/dc/dcmitype/"/>
    <ds:schemaRef ds:uri="http://schemas.microsoft.com/office/infopath/2007/PartnerControls"/>
    <ds:schemaRef ds:uri="http://schemas.openxmlformats.org/package/2006/metadata/core-properties"/>
    <ds:schemaRef ds:uri="941eeea9-a65b-4b11-8fbe-8d30452b0442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4842</TotalTime>
  <Words>708</Words>
  <Application>Microsoft Office PowerPoint</Application>
  <PresentationFormat>A4 Paper (210x297 mm)</PresentationFormat>
  <Paragraphs>159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6" baseType="lpstr">
      <vt:lpstr>MS Mincho</vt:lpstr>
      <vt:lpstr>新細明體</vt:lpstr>
      <vt:lpstr>Arial</vt:lpstr>
      <vt:lpstr>Calibri</vt:lpstr>
      <vt:lpstr>Calibri Light</vt:lpstr>
      <vt:lpstr>Helvetica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 Ka LEE</dc:creator>
  <cp:lastModifiedBy>Chris K C WONG</cp:lastModifiedBy>
  <cp:revision>74</cp:revision>
  <cp:lastPrinted>2023-09-18T01:20:33Z</cp:lastPrinted>
  <dcterms:created xsi:type="dcterms:W3CDTF">2023-07-27T18:41:27Z</dcterms:created>
  <dcterms:modified xsi:type="dcterms:W3CDTF">2023-10-27T03:05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AFA50CBBF4CD142BAF55481075BDAD2</vt:lpwstr>
  </property>
</Properties>
</file>